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2586" y="-84"/>
      </p:cViewPr>
      <p:guideLst>
        <p:guide orient="horz" pos="2880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7394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1023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1318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5758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9277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7455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8705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3373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1457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011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5777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D934A-D06B-43AC-8EAF-66E034C37CDC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99DD5-6317-4888-B2B3-AFB0D4559E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5367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266699" y="-34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A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66699" y="39346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/>
                <a:cs typeface="Arial"/>
              </a:rPr>
              <a:t>B</a:t>
            </a:r>
            <a:endParaRPr lang="de-DE" dirty="0">
              <a:latin typeface="Arial"/>
              <a:cs typeface="Arial"/>
            </a:endParaRPr>
          </a:p>
        </p:txBody>
      </p:sp>
      <p:pic>
        <p:nvPicPr>
          <p:cNvPr id="5" name="Bild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644" y="81593"/>
            <a:ext cx="4040499" cy="3664260"/>
          </a:xfrm>
          <a:prstGeom prst="rect">
            <a:avLst/>
          </a:prstGeom>
        </p:spPr>
      </p:pic>
      <p:pic>
        <p:nvPicPr>
          <p:cNvPr id="6" name="Bild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9118" y="3910132"/>
            <a:ext cx="5038821" cy="3498518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0" y="7308304"/>
            <a:ext cx="68580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Fig</a:t>
            </a:r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S2. </a:t>
            </a:r>
            <a:endParaRPr lang="de-DE" sz="1100" b="1" dirty="0" smtClean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  <a:p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a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Plot of pairwise correlations (Spearman) of baseline concentrations of individual cytokines.</a:t>
            </a:r>
            <a:endParaRPr lang="de-DE" sz="1100" b="1" dirty="0" smtClean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  <a:p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b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</a:t>
            </a:r>
            <a:r>
              <a:rPr lang="en-US" sz="1100" b="0" dirty="0" err="1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Heatmap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of baseline concentrations (</a:t>
            </a:r>
            <a:r>
              <a:rPr lang="en-US" sz="1100" b="0" dirty="0" err="1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Gehan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u-score) of a selection of 9 cytokines. MTD group: &lt;280 = MTD reached was below 280 mg/m</a:t>
            </a:r>
            <a:r>
              <a:rPr lang="en-US" sz="1100" b="0" baseline="3000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2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, &gt;=280 = MTD reached was equal to or above 280mg/m</a:t>
            </a:r>
            <a:r>
              <a:rPr lang="en-US" sz="1100" b="0" baseline="3000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2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, not reached = MTD was not reached; Best Response: PD: best response progressive disease; PR/SD: best response partial response or stable disease; not assessable: best response not assessable. L1-penalized logistic regression was used to discard strongly correlated cytokines for cluster assignment.</a:t>
            </a:r>
            <a:endParaRPr lang="de-DE" sz="1100" b="1" dirty="0" smtClean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0140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60350" y="1011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/>
                <a:cs typeface="Arial"/>
              </a:rPr>
              <a:t>C</a:t>
            </a:r>
            <a:endParaRPr lang="de-DE" dirty="0">
              <a:latin typeface="Arial"/>
              <a:cs typeface="Arial"/>
            </a:endParaRPr>
          </a:p>
        </p:txBody>
      </p:sp>
      <p:pic>
        <p:nvPicPr>
          <p:cNvPr id="3" name="Bild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61311"/>
            <a:ext cx="6858000" cy="5338119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0" y="7308304"/>
            <a:ext cx="6858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Fig</a:t>
            </a:r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S2. </a:t>
            </a:r>
            <a:endParaRPr lang="de-DE" sz="1100" b="1" dirty="0" smtClean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  <a:p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Longitudinal analysis of mean values of cytokines, separated by MTD groups. &gt;=280: MTD reached was equal to or above 280 mg/m2. &lt;280: MTD reached was below 280 mg/m2. not reached: MTD was not reached. </a:t>
            </a:r>
            <a:endParaRPr lang="de-DE" sz="1100" b="1" dirty="0" smtClean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51104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42132" y="1204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/>
                <a:cs typeface="Arial"/>
              </a:rPr>
              <a:t>D</a:t>
            </a:r>
            <a:endParaRPr lang="de-DE" dirty="0">
              <a:latin typeface="Arial"/>
              <a:cs typeface="Arial"/>
            </a:endParaRPr>
          </a:p>
        </p:txBody>
      </p:sp>
      <p:pic>
        <p:nvPicPr>
          <p:cNvPr id="4" name="Bild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74010"/>
            <a:ext cx="6858000" cy="5318125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0" y="7308304"/>
            <a:ext cx="6858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Fig</a:t>
            </a:r>
            <a:r>
              <a:rPr lang="en-US" sz="1100" b="1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. S3. </a:t>
            </a:r>
            <a:endParaRPr lang="de-DE" sz="1100" b="1" dirty="0" smtClean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  <a:p>
            <a:r>
              <a:rPr lang="en-US" sz="11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d</a:t>
            </a:r>
            <a:r>
              <a:rPr lang="en-US" sz="1100" b="0" dirty="0" smtClean="0">
                <a:effectLst/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Longitudinal analysis of mean values of cytokines, separated by best response groups. PR/SD: best response PR or SD. PD: best response PD. not assessable: best response not assessable.</a:t>
            </a:r>
            <a:endParaRPr lang="de-DE" sz="1100" b="1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1626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4</Words>
  <Application>Microsoft Office PowerPoint</Application>
  <PresentationFormat>Bildschirmpräsentation (4:3)</PresentationFormat>
  <Paragraphs>11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Universitätsklinikum Heidelbe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antilbu</dc:creator>
  <cp:lastModifiedBy>vantilbu</cp:lastModifiedBy>
  <cp:revision>4</cp:revision>
  <dcterms:created xsi:type="dcterms:W3CDTF">2019-06-14T10:46:57Z</dcterms:created>
  <dcterms:modified xsi:type="dcterms:W3CDTF">2019-08-02T16:16:03Z</dcterms:modified>
</cp:coreProperties>
</file>